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2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8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7744" y="33465"/>
            <a:ext cx="4536504" cy="541175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2008" y="5301208"/>
            <a:ext cx="9036496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pecific GO terms uniquely enriched in Group III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arboring pervasive interactions a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a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b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ollen sterility loci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Significant GO categories uniquely enriched in Group III. P indicates biological process category. M indicates molecular function category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GO enrichment analysis results of biological process category in Group III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O enrichment analysis results of molecular function category in Group III.  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23824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1</cp:revision>
  <dcterms:modified xsi:type="dcterms:W3CDTF">2017-08-05T07:33:20Z</dcterms:modified>
</cp:coreProperties>
</file>